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1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67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258AEA-70D6-4804-BA10-0AD4323A7E87}" type="datetimeFigureOut">
              <a:rPr lang="zh-CN" altLang="en-US" smtClean="0"/>
              <a:t>2023-08-2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1A07A3-F005-4171-9156-4C1FDAF217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44163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3B75103-CC43-6FD4-8B68-AD806CDE54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A894B7F-2033-59D3-7959-E7FE1CC1D31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82896B6-5620-513D-24F8-7DA8284F19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5579E-E3A5-4277-BBEF-27A378164BD9}" type="datetimeFigureOut">
              <a:rPr lang="zh-CN" altLang="en-US" smtClean="0"/>
              <a:t>2023-08-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6528074-C1BB-B4BE-022E-CB8E9F1FD7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0B6EFD8-7C3B-3D43-7A70-E626196A59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33F4D-9B9D-453B-AB46-A102C67482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8178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F90BB0-5B53-B0D3-5E3D-D12AE7D2BE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87A9DEB-CE0B-E76E-4FEF-E4981B466D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F49617D-E3EB-969D-2A4B-DD20AB5E18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5579E-E3A5-4277-BBEF-27A378164BD9}" type="datetimeFigureOut">
              <a:rPr lang="zh-CN" altLang="en-US" smtClean="0"/>
              <a:t>2023-08-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77D1588-BC27-A0F9-6629-C1D11DBDB5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B1D2CBB-654E-2DC1-BD75-CDAF484E15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33F4D-9B9D-453B-AB46-A102C67482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32220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5331066-633B-DF3E-0F6A-71B418DBAA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A50D3E0-F659-1186-3D7D-5933EA2B2B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9742A96-2C7E-264F-E451-8D347B3791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5579E-E3A5-4277-BBEF-27A378164BD9}" type="datetimeFigureOut">
              <a:rPr lang="zh-CN" altLang="en-US" smtClean="0"/>
              <a:t>2023-08-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807072B-B030-8D10-92AF-64231D2735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A9E75D8-8B8F-B85E-E6EC-820D2C9E8D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33F4D-9B9D-453B-AB46-A102C67482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74781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3FB38E-E9D5-8E07-6E70-10170AEEEB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1495CB2-902F-CAB4-E1E9-3F0151E951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67E4E4-045D-394F-B10D-A17EB673CC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5579E-E3A5-4277-BBEF-27A378164BD9}" type="datetimeFigureOut">
              <a:rPr lang="zh-CN" altLang="en-US" smtClean="0"/>
              <a:t>2023-08-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818729A-59AD-6887-8E8E-8FB18FFE0D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BD6D373-717E-371A-AB07-2113F53A6E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33F4D-9B9D-453B-AB46-A102C67482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60849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FA08CCD-8425-431E-80F3-615327AC5E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A5CABC9-47D5-65D8-EB89-1DB28C5CA7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B333C1F-B6A9-6869-A59B-F92DADDC52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5579E-E3A5-4277-BBEF-27A378164BD9}" type="datetimeFigureOut">
              <a:rPr lang="zh-CN" altLang="en-US" smtClean="0"/>
              <a:t>2023-08-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C57BAAF-25BC-CCEF-985E-35915CC15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A59DDF4-544D-7D62-2734-8B0BF3971F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33F4D-9B9D-453B-AB46-A102C67482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90463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745C3B0-9806-7C03-4BE3-6D8A0BC23E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5B7EE88-514F-FF60-59FA-AD0DA917D24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47D682A-BF15-B593-785C-5A393D2511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8131F2A-D911-88F8-2E9F-18AA57FE59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5579E-E3A5-4277-BBEF-27A378164BD9}" type="datetimeFigureOut">
              <a:rPr lang="zh-CN" altLang="en-US" smtClean="0"/>
              <a:t>2023-08-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A22D532-6D05-55EA-688D-921E18BBBB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382F375-EBDB-15A6-66C6-4A04730C8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33F4D-9B9D-453B-AB46-A102C67482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41983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E0814D9-A111-311D-E42B-AC0D1F70BD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65C4363-D218-BEA8-08DC-119B850B98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A37F362-AABD-AE5D-781A-E013DAB832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4126F1F-7571-6469-4DE9-03A73F8FF78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F53DA25-6D74-A96A-9E77-E7DA48C185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3CA4B3A-3DA4-C64F-43E2-E8A8DC6A93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5579E-E3A5-4277-BBEF-27A378164BD9}" type="datetimeFigureOut">
              <a:rPr lang="zh-CN" altLang="en-US" smtClean="0"/>
              <a:t>2023-08-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35475A5-EC5D-4C7E-49CA-E8C7DC63C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CBD3513-6F1B-8899-DD9C-7378A2E710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33F4D-9B9D-453B-AB46-A102C67482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9661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C22150-D20F-5E27-5E16-B696A771C4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1A0A334-68BE-498E-6DE0-92D8FA5273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5579E-E3A5-4277-BBEF-27A378164BD9}" type="datetimeFigureOut">
              <a:rPr lang="zh-CN" altLang="en-US" smtClean="0"/>
              <a:t>2023-08-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0FF27F0-D2FC-9BFD-BE14-17FE7230B8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DBFEE00-AE54-4A35-1A5F-A1CF3F2885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33F4D-9B9D-453B-AB46-A102C67482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45032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D2CCC9D-6E3A-6A3A-FD8D-2E51BF7AD3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5579E-E3A5-4277-BBEF-27A378164BD9}" type="datetimeFigureOut">
              <a:rPr lang="zh-CN" altLang="en-US" smtClean="0"/>
              <a:t>2023-08-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79126FC-FCE9-078C-6EDA-207EB8B36B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27DBB64-6787-2CA4-391C-31A5179499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33F4D-9B9D-453B-AB46-A102C67482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7962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2383B4-01B7-FB1F-A8D1-1E7E2F0A28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00CB5C6-AEAD-7C09-5606-256695E5C0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A6E90D2-C54B-9962-20BC-3FC8D59898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D0362EE-8E20-DAF3-0610-FAD420A07A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5579E-E3A5-4277-BBEF-27A378164BD9}" type="datetimeFigureOut">
              <a:rPr lang="zh-CN" altLang="en-US" smtClean="0"/>
              <a:t>2023-08-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4E7ED8D-5F09-95BF-F5E8-D702F94F05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702ACF9-E36D-3843-194D-8EB0630903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33F4D-9B9D-453B-AB46-A102C67482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72553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B885D85-670D-17DF-504A-B52A8EBE91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C4FD3B2-706E-F479-F3BE-74322A05D54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43A86E8-DA5E-4679-E0FE-493E6093D6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7A8880E-2AE2-BBFB-33E7-74160BF934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5579E-E3A5-4277-BBEF-27A378164BD9}" type="datetimeFigureOut">
              <a:rPr lang="zh-CN" altLang="en-US" smtClean="0"/>
              <a:t>2023-08-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A6AB82A-F08F-01CD-F0F3-3D9FC70222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F03ED0B-3276-846B-55F2-D3D626F6D2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33F4D-9B9D-453B-AB46-A102C67482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7056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D5B2F84-B5E3-027B-23A5-6607B375CB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6462523-4B5B-4262-C5BC-C423398253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D552D4C-E42A-B491-11DB-FF46C2699D3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55579E-E3A5-4277-BBEF-27A378164BD9}" type="datetimeFigureOut">
              <a:rPr lang="zh-CN" altLang="en-US" smtClean="0"/>
              <a:t>2023-08-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3292BAD-77E2-4F70-4845-00D02EB4E8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0089E29-B42F-B579-7E65-DFA04EC65E4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233F4D-9B9D-453B-AB46-A102C67482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93470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F2757347-0EC6-956A-CD45-1E0E7182FE79}"/>
              </a:ext>
            </a:extLst>
          </p:cNvPr>
          <p:cNvSpPr txBox="1"/>
          <p:nvPr/>
        </p:nvSpPr>
        <p:spPr>
          <a:xfrm>
            <a:off x="2905125" y="170771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.1 Treatments of the pot experiments.</a:t>
            </a:r>
          </a:p>
        </p:txBody>
      </p:sp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4A99481C-01DF-EDCB-57AD-F39BC171833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21169540"/>
              </p:ext>
            </p:extLst>
          </p:nvPr>
        </p:nvGraphicFramePr>
        <p:xfrm>
          <a:off x="2551347" y="2306681"/>
          <a:ext cx="6941444" cy="326456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765175">
                  <a:extLst>
                    <a:ext uri="{9D8B030D-6E8A-4147-A177-3AD203B41FA5}">
                      <a16:colId xmlns:a16="http://schemas.microsoft.com/office/drawing/2014/main" val="2257781462"/>
                    </a:ext>
                  </a:extLst>
                </a:gridCol>
                <a:gridCol w="5176269">
                  <a:extLst>
                    <a:ext uri="{9D8B030D-6E8A-4147-A177-3AD203B41FA5}">
                      <a16:colId xmlns:a16="http://schemas.microsoft.com/office/drawing/2014/main" val="487496383"/>
                    </a:ext>
                  </a:extLst>
                </a:gridCol>
              </a:tblGrid>
              <a:tr h="817559"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200">
                          <a:effectLst/>
                        </a:rPr>
                        <a:t>Code of treatments</a:t>
                      </a:r>
                      <a:endParaRPr lang="zh-C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050">
                          <a:effectLst/>
                        </a:rPr>
                        <a:t>Description</a:t>
                      </a:r>
                      <a:endParaRPr lang="zh-C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964049652"/>
                  </a:ext>
                </a:extLst>
              </a:tr>
              <a:tr h="408779"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050">
                          <a:effectLst/>
                        </a:rPr>
                        <a:t>BCK</a:t>
                      </a:r>
                      <a:endParaRPr lang="zh-C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050">
                          <a:effectLst/>
                        </a:rPr>
                        <a:t>Control in Brazilian cultivar with </a:t>
                      </a:r>
                      <a:r>
                        <a:rPr lang="en-US" sz="1200">
                          <a:effectLst/>
                        </a:rPr>
                        <a:t>normal tap </a:t>
                      </a:r>
                      <a:r>
                        <a:rPr lang="en-US" sz="1050">
                          <a:effectLst/>
                        </a:rPr>
                        <a:t>water</a:t>
                      </a:r>
                      <a:endParaRPr lang="zh-C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514350016"/>
                  </a:ext>
                </a:extLst>
              </a:tr>
              <a:tr h="407361"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050">
                          <a:effectLst/>
                        </a:rPr>
                        <a:t>BTR4</a:t>
                      </a:r>
                      <a:endParaRPr lang="zh-C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050">
                          <a:effectLst/>
                        </a:rPr>
                        <a:t>Brazilian inoculated with TR4 in pot soil</a:t>
                      </a:r>
                      <a:endParaRPr lang="zh-C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265117733"/>
                  </a:ext>
                </a:extLst>
              </a:tr>
              <a:tr h="407361"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050">
                          <a:effectLst/>
                        </a:rPr>
                        <a:t>BTR4+QST713</a:t>
                      </a:r>
                      <a:endParaRPr lang="zh-C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050">
                          <a:effectLst/>
                        </a:rPr>
                        <a:t>QST713 drenched to Brazilian and inoculated with TR4 in pot soil</a:t>
                      </a:r>
                      <a:endParaRPr lang="zh-C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159122496"/>
                  </a:ext>
                </a:extLst>
              </a:tr>
              <a:tr h="408779"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050">
                          <a:effectLst/>
                        </a:rPr>
                        <a:t>YCK</a:t>
                      </a:r>
                      <a:endParaRPr lang="zh-C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050">
                          <a:effectLst/>
                        </a:rPr>
                        <a:t>Control in Yunjiao No.1 cultivar with </a:t>
                      </a:r>
                      <a:r>
                        <a:rPr lang="en-US" sz="1200">
                          <a:effectLst/>
                        </a:rPr>
                        <a:t>normal tap </a:t>
                      </a:r>
                      <a:r>
                        <a:rPr lang="en-US" sz="1050">
                          <a:effectLst/>
                        </a:rPr>
                        <a:t>water</a:t>
                      </a:r>
                      <a:endParaRPr lang="zh-C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94272275"/>
                  </a:ext>
                </a:extLst>
              </a:tr>
              <a:tr h="407361"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050">
                          <a:effectLst/>
                        </a:rPr>
                        <a:t>YTR4</a:t>
                      </a:r>
                      <a:endParaRPr lang="zh-C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050">
                          <a:effectLst/>
                        </a:rPr>
                        <a:t>Yunjiao No.1 inoculated with TR4 in pot soil</a:t>
                      </a:r>
                      <a:endParaRPr lang="zh-C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485370321"/>
                  </a:ext>
                </a:extLst>
              </a:tr>
              <a:tr h="407361"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050">
                          <a:effectLst/>
                        </a:rPr>
                        <a:t>YTR4+QST713</a:t>
                      </a:r>
                      <a:endParaRPr lang="zh-CN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050" dirty="0">
                          <a:effectLst/>
                        </a:rPr>
                        <a:t>QST713 drenched to </a:t>
                      </a:r>
                      <a:r>
                        <a:rPr lang="en-US" sz="1050" dirty="0" err="1">
                          <a:effectLst/>
                        </a:rPr>
                        <a:t>Yunjiao</a:t>
                      </a:r>
                      <a:r>
                        <a:rPr lang="en-US" sz="1050" dirty="0">
                          <a:effectLst/>
                        </a:rPr>
                        <a:t> No.1 and inoculated with TR4 in pot soil</a:t>
                      </a:r>
                      <a:endParaRPr lang="zh-CN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86827062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210510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</TotalTime>
  <Words>84</Words>
  <Application>Microsoft Office PowerPoint</Application>
  <PresentationFormat>宽屏</PresentationFormat>
  <Paragraphs>1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张 文龙</dc:creator>
  <cp:lastModifiedBy>Zheng, Sijun (Alliance Bioversity-CIAT)</cp:lastModifiedBy>
  <cp:revision>13</cp:revision>
  <dcterms:created xsi:type="dcterms:W3CDTF">2023-03-25T13:26:51Z</dcterms:created>
  <dcterms:modified xsi:type="dcterms:W3CDTF">2023-08-29T13:08:52Z</dcterms:modified>
</cp:coreProperties>
</file>